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FB961-F9D2-4134-8BC1-2457A18B40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1EB9E-57AC-4C1B-8600-D7A7AC98A5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7E248-9C95-46CD-B4A9-833CF62FC1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A3FA04-4CEB-41C0-A024-F34B7938FA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40B9E-7D5C-4F3C-81C5-85BFB52B9F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3C20A-1B3A-40D3-ACE6-7CCFD59D71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86B8D-F1D3-4827-8434-369D599768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2A264-D340-4C15-899B-2CDBBF3016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7EDEF-2C4A-49C8-96EE-08975C8339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13C51-92EF-4951-AF10-2D754AA2CE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1FC56-B40F-4ED7-97FE-2766E74AE9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F8489-81AA-417C-9F74-474637C0CD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AC7F3D-6359-42BA-8A9C-5BCD006E618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3505320"/>
            <a:ext cx="6477120" cy="2590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28600" y="838080"/>
            <a:ext cx="6477120" cy="2590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276200" y="914400"/>
            <a:ext cx="438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alamus and Putamen: 4 x 4 microwires staggered array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04920" y="122400"/>
            <a:ext cx="6400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3) Multielectrode array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: Teflon-coated tungsten wires (5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 diameter, 3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 between wires, 1.0-1.2M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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@1KHz, California Fine Wire Co., Grover Beach, CA, USA ) were assembled in multielectrode arrays shaped to fit different neuroanatomical target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 flipH="1" flipV="1">
            <a:off x="1981080" y="1693080"/>
            <a:ext cx="152640" cy="1295640"/>
          </a:xfrm>
          <a:custGeom>
            <a:avLst/>
            <a:gdLst>
              <a:gd name="textAreaLeft" fmla="*/ 97560 w 152640"/>
              <a:gd name="textAreaRight" fmla="*/ 153000 w 152640"/>
              <a:gd name="textAreaTop" fmla="*/ 33480 h 1295640"/>
              <a:gd name="textAreaBottom" fmla="*/ 1262160 h 1295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6" name=""/>
          <p:cNvGrpSpPr/>
          <p:nvPr/>
        </p:nvGrpSpPr>
        <p:grpSpPr>
          <a:xfrm>
            <a:off x="1143000" y="1312920"/>
            <a:ext cx="609480" cy="368280"/>
            <a:chOff x="1143000" y="1312920"/>
            <a:chExt cx="609480" cy="368280"/>
          </a:xfrm>
        </p:grpSpPr>
        <p:sp>
          <p:nvSpPr>
            <p:cNvPr id="47" name=""/>
            <p:cNvSpPr/>
            <p:nvPr/>
          </p:nvSpPr>
          <p:spPr>
            <a:xfrm>
              <a:off x="1143000" y="1541520"/>
              <a:ext cx="609480" cy="139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18944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25136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31328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37520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43748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49904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56132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62324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68516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747080" y="144648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143000" y="1312920"/>
              <a:ext cx="609480" cy="177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1523880" y="1693800"/>
            <a:ext cx="0" cy="106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600200" y="169380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676520" y="1676520"/>
            <a:ext cx="0" cy="1218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1752480" y="1676520"/>
            <a:ext cx="0" cy="1295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133720" y="22273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 mm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914400" y="1693800"/>
            <a:ext cx="152280" cy="1067040"/>
          </a:xfrm>
          <a:custGeom>
            <a:avLst/>
            <a:gdLst>
              <a:gd name="textAreaLeft" fmla="*/ 97200 w 152280"/>
              <a:gd name="textAreaRight" fmla="*/ 152640 w 152280"/>
              <a:gd name="textAreaTop" fmla="*/ 27720 h 1067040"/>
              <a:gd name="textAreaBottom" fmla="*/ 1039320 h 1067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76320" y="207504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 mm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5083200" y="1295280"/>
            <a:ext cx="1036440" cy="1752840"/>
          </a:xfrm>
          <a:prstGeom prst="rect">
            <a:avLst/>
          </a:prstGeom>
          <a:ln w="0">
            <a:noFill/>
          </a:ln>
        </p:spPr>
      </p:pic>
      <p:grpSp>
        <p:nvGrpSpPr>
          <p:cNvPr id="67" name=""/>
          <p:cNvGrpSpPr/>
          <p:nvPr/>
        </p:nvGrpSpPr>
        <p:grpSpPr>
          <a:xfrm>
            <a:off x="3657600" y="1295280"/>
            <a:ext cx="228600" cy="1676160"/>
            <a:chOff x="3657600" y="1295280"/>
            <a:chExt cx="228600" cy="1676160"/>
          </a:xfrm>
        </p:grpSpPr>
        <p:sp>
          <p:nvSpPr>
            <p:cNvPr id="68" name=""/>
            <p:cNvSpPr/>
            <p:nvPr/>
          </p:nvSpPr>
          <p:spPr>
            <a:xfrm>
              <a:off x="3657600" y="15238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733560" y="167616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93960" y="1447560"/>
              <a:ext cx="0" cy="13500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657600" y="12952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657600" y="167616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809880" y="152388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886200" y="167616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846240" y="1447560"/>
              <a:ext cx="0" cy="13500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809880" y="129528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809880" y="167616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8" name=""/>
          <p:cNvSpPr/>
          <p:nvPr/>
        </p:nvSpPr>
        <p:spPr>
          <a:xfrm>
            <a:off x="228600" y="6172200"/>
            <a:ext cx="6477120" cy="2590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1581120" y="3581280"/>
            <a:ext cx="377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ppocampus: 4 x 8 microwires staggered array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114800" y="48769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 mm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809880" y="4267080"/>
            <a:ext cx="76320" cy="152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114800" y="4419720"/>
            <a:ext cx="76320" cy="1143000"/>
          </a:xfrm>
          <a:custGeom>
            <a:avLst/>
            <a:gdLst>
              <a:gd name="textAreaLeft" fmla="*/ 0 w 76320"/>
              <a:gd name="textAreaRight" fmla="*/ 27360 w 76320"/>
              <a:gd name="textAreaTop" fmla="*/ 29520 h 1143000"/>
              <a:gd name="textAreaBottom" fmla="*/ 1113480 h 1143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886200" y="441972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846600" y="4191120"/>
            <a:ext cx="0" cy="134640"/>
          </a:xfrm>
          <a:prstGeom prst="line">
            <a:avLst/>
          </a:prstGeom>
          <a:ln w="255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3809880" y="4038480"/>
            <a:ext cx="76320" cy="152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2590920" y="47545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.2 mm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flipH="1">
            <a:off x="3276000" y="4419720"/>
            <a:ext cx="152280" cy="990360"/>
          </a:xfrm>
          <a:custGeom>
            <a:avLst/>
            <a:gdLst>
              <a:gd name="textAreaLeft" fmla="*/ 0 w 152280"/>
              <a:gd name="textAreaRight" fmla="*/ 55080 w 152280"/>
              <a:gd name="textAreaTop" fmla="*/ 25560 h 990360"/>
              <a:gd name="textAreaBottom" fmla="*/ 964800 h 99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1070280" y="5745240"/>
            <a:ext cx="48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de view                                      Front view                             Pictur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1181160" y="4343400"/>
            <a:ext cx="533520" cy="1295280"/>
            <a:chOff x="1181160" y="4343400"/>
            <a:chExt cx="533520" cy="1295280"/>
          </a:xfrm>
        </p:grpSpPr>
        <p:sp>
          <p:nvSpPr>
            <p:cNvPr id="90" name=""/>
            <p:cNvSpPr/>
            <p:nvPr/>
          </p:nvSpPr>
          <p:spPr>
            <a:xfrm>
              <a:off x="171468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63836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56240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48608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40976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33380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25748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181160" y="4343400"/>
              <a:ext cx="0" cy="12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1070280" y="3154320"/>
            <a:ext cx="48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de view                                      Front view                             Pictur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714680" y="6248520"/>
            <a:ext cx="350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rebral Cortex: 4 x 8 microwires flat array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905120" y="76960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 mm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828800" y="7467480"/>
            <a:ext cx="152280" cy="685800"/>
          </a:xfrm>
          <a:custGeom>
            <a:avLst/>
            <a:gdLst>
              <a:gd name="textAreaLeft" fmla="*/ 0 w 152280"/>
              <a:gd name="textAreaRight" fmla="*/ 55080 w 152280"/>
              <a:gd name="textAreaTop" fmla="*/ 17640 h 685800"/>
              <a:gd name="textAreaBottom" fmla="*/ 668160 h 685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2" name=""/>
          <p:cNvGrpSpPr/>
          <p:nvPr/>
        </p:nvGrpSpPr>
        <p:grpSpPr>
          <a:xfrm>
            <a:off x="1181160" y="7467480"/>
            <a:ext cx="533520" cy="639720"/>
            <a:chOff x="1181160" y="7467480"/>
            <a:chExt cx="533520" cy="639720"/>
          </a:xfrm>
        </p:grpSpPr>
        <p:sp>
          <p:nvSpPr>
            <p:cNvPr id="103" name=""/>
            <p:cNvSpPr/>
            <p:nvPr/>
          </p:nvSpPr>
          <p:spPr>
            <a:xfrm>
              <a:off x="133344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40976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48608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56204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71468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63836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25748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181160" y="7467480"/>
              <a:ext cx="0" cy="63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1" name=""/>
          <p:cNvGrpSpPr/>
          <p:nvPr/>
        </p:nvGrpSpPr>
        <p:grpSpPr>
          <a:xfrm>
            <a:off x="3429000" y="7086600"/>
            <a:ext cx="533520" cy="1020240"/>
            <a:chOff x="3429000" y="7086600"/>
            <a:chExt cx="533520" cy="1020240"/>
          </a:xfrm>
        </p:grpSpPr>
        <p:sp>
          <p:nvSpPr>
            <p:cNvPr id="112" name=""/>
            <p:cNvSpPr/>
            <p:nvPr/>
          </p:nvSpPr>
          <p:spPr>
            <a:xfrm>
              <a:off x="3429000" y="731484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465360" y="7238880"/>
              <a:ext cx="0" cy="134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429000" y="708660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581280" y="731484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618000" y="7238880"/>
              <a:ext cx="0" cy="134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581280" y="708660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733920" y="731484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770280" y="7238880"/>
              <a:ext cx="0" cy="134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733920" y="708660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886200" y="731484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922560" y="7238880"/>
              <a:ext cx="0" cy="134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886200" y="7086600"/>
              <a:ext cx="7632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505320" y="7467480"/>
              <a:ext cx="0" cy="63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657600" y="7467480"/>
              <a:ext cx="0" cy="63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809880" y="7467480"/>
              <a:ext cx="0" cy="63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962520" y="7467480"/>
              <a:ext cx="0" cy="63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128" name="" descr=""/>
          <p:cNvPicPr/>
          <p:nvPr/>
        </p:nvPicPr>
        <p:blipFill>
          <a:blip r:embed="rId2"/>
          <a:stretch/>
        </p:blipFill>
        <p:spPr>
          <a:xfrm>
            <a:off x="5029200" y="6858000"/>
            <a:ext cx="1228680" cy="1371600"/>
          </a:xfrm>
          <a:prstGeom prst="rect">
            <a:avLst/>
          </a:prstGeom>
          <a:ln w="0">
            <a:noFill/>
          </a:ln>
        </p:spPr>
      </p:pic>
      <p:sp>
        <p:nvSpPr>
          <p:cNvPr id="129" name=""/>
          <p:cNvSpPr/>
          <p:nvPr/>
        </p:nvSpPr>
        <p:spPr>
          <a:xfrm>
            <a:off x="1070280" y="8335800"/>
            <a:ext cx="487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de view                                      Front view                             Pictur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0" name=""/>
          <p:cNvGrpSpPr/>
          <p:nvPr/>
        </p:nvGrpSpPr>
        <p:grpSpPr>
          <a:xfrm>
            <a:off x="3505320" y="4038480"/>
            <a:ext cx="75960" cy="1371600"/>
            <a:chOff x="3505320" y="4038480"/>
            <a:chExt cx="75960" cy="1371600"/>
          </a:xfrm>
        </p:grpSpPr>
        <p:sp>
          <p:nvSpPr>
            <p:cNvPr id="131" name=""/>
            <p:cNvSpPr/>
            <p:nvPr/>
          </p:nvSpPr>
          <p:spPr>
            <a:xfrm>
              <a:off x="3505320" y="42670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581280" y="441936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541680" y="4190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505320" y="40384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35" name=""/>
          <p:cNvGrpSpPr/>
          <p:nvPr/>
        </p:nvGrpSpPr>
        <p:grpSpPr>
          <a:xfrm>
            <a:off x="3657600" y="4038480"/>
            <a:ext cx="75960" cy="1371600"/>
            <a:chOff x="3657600" y="4038480"/>
            <a:chExt cx="75960" cy="1371600"/>
          </a:xfrm>
        </p:grpSpPr>
        <p:sp>
          <p:nvSpPr>
            <p:cNvPr id="136" name=""/>
            <p:cNvSpPr/>
            <p:nvPr/>
          </p:nvSpPr>
          <p:spPr>
            <a:xfrm>
              <a:off x="3657600" y="42670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3733560" y="441936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693960" y="4190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657600" y="4038480"/>
              <a:ext cx="75960" cy="15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40" name=""/>
          <p:cNvSpPr/>
          <p:nvPr/>
        </p:nvSpPr>
        <p:spPr>
          <a:xfrm>
            <a:off x="3962520" y="4267080"/>
            <a:ext cx="75960" cy="152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4038480" y="441972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3998880" y="4191120"/>
            <a:ext cx="0" cy="134640"/>
          </a:xfrm>
          <a:prstGeom prst="line">
            <a:avLst/>
          </a:prstGeom>
          <a:ln w="255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3962520" y="4038480"/>
            <a:ext cx="75960" cy="152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4" name=""/>
          <p:cNvGrpSpPr/>
          <p:nvPr/>
        </p:nvGrpSpPr>
        <p:grpSpPr>
          <a:xfrm>
            <a:off x="1143000" y="7099200"/>
            <a:ext cx="609480" cy="368280"/>
            <a:chOff x="1143000" y="7099200"/>
            <a:chExt cx="609480" cy="368280"/>
          </a:xfrm>
        </p:grpSpPr>
        <p:sp>
          <p:nvSpPr>
            <p:cNvPr id="145" name=""/>
            <p:cNvSpPr/>
            <p:nvPr/>
          </p:nvSpPr>
          <p:spPr>
            <a:xfrm>
              <a:off x="1143000" y="7327800"/>
              <a:ext cx="609480" cy="139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18944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25136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31328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37520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43748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49904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56132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62324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68516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747080" y="723276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143000" y="7099200"/>
              <a:ext cx="609480" cy="177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57" name=""/>
          <p:cNvGrpSpPr/>
          <p:nvPr/>
        </p:nvGrpSpPr>
        <p:grpSpPr>
          <a:xfrm>
            <a:off x="1143000" y="4038480"/>
            <a:ext cx="609480" cy="368280"/>
            <a:chOff x="1143000" y="4038480"/>
            <a:chExt cx="609480" cy="368280"/>
          </a:xfrm>
        </p:grpSpPr>
        <p:sp>
          <p:nvSpPr>
            <p:cNvPr id="158" name=""/>
            <p:cNvSpPr/>
            <p:nvPr/>
          </p:nvSpPr>
          <p:spPr>
            <a:xfrm>
              <a:off x="1143000" y="4267080"/>
              <a:ext cx="609480" cy="139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18944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25136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31328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37520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43748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49904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56132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62324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68516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747080" y="4172040"/>
              <a:ext cx="0" cy="152280"/>
            </a:xfrm>
            <a:prstGeom prst="line">
              <a:avLst/>
            </a:prstGeom>
            <a:ln w="255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143000" y="4038480"/>
              <a:ext cx="609480" cy="177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170" name="" descr=""/>
          <p:cNvPicPr/>
          <p:nvPr/>
        </p:nvPicPr>
        <p:blipFill>
          <a:blip r:embed="rId3"/>
          <a:stretch/>
        </p:blipFill>
        <p:spPr>
          <a:xfrm>
            <a:off x="5029200" y="4057560"/>
            <a:ext cx="1073160" cy="150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3-27T01:46:11Z</dcterms:created>
  <dc:creator>Sidarta Ribeiro</dc:creator>
  <dc:description/>
  <dc:language>en-US</dc:language>
  <cp:lastModifiedBy>Liana Holmberg</cp:lastModifiedBy>
  <dcterms:modified xsi:type="dcterms:W3CDTF">2003-12-05T00:12:40Z</dcterms:modified>
  <cp:revision>86</cp:revision>
  <dc:subject/>
  <dc:title>Supplementary Material</dc:title>
</cp:coreProperties>
</file>